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29"/>
  </p:normalViewPr>
  <p:slideViewPr>
    <p:cSldViewPr snapToGrid="0">
      <p:cViewPr varScale="1">
        <p:scale>
          <a:sx n="108" d="100"/>
          <a:sy n="108" d="100"/>
        </p:scale>
        <p:origin x="7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16C926-B034-44D7-82AF-6D3715ADC967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0A09D5-42F4-4DBF-9007-985CE686AE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3461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5F49B3-7D48-485E-AFEC-C095AF7AC6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E1C5159-D135-4375-80CC-AD19AFF426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DD1B7B-2934-4ECC-88E8-590525446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9B5C47-79A0-451A-A0CC-F3E1F814C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6AA7E0-D46C-40CA-B0DA-DE4D79494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9846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D99D66-A594-4309-B037-9B9FCB45EB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27C0E0D-99AC-492D-A7E7-23128D36F3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0371E4-56C7-437C-9759-3C45BCAE5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A789D0-27B0-4574-9D5C-A5F2654C2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4C0806-E7CB-46D9-995E-F1D7DBDF0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1695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35B3EF9-F3ED-4AB3-8533-F78B9C4E2B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C1CD2B-7CBB-4320-A921-A1E356128B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98A957-F2C7-49D2-B2B1-DABBA6121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851A19-EC5A-443C-999D-6EBB293D6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724672-BFB5-4087-96B4-76A0C69FB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3543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067D19-9285-4D4D-B92D-054253112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3E7390-2C4A-4FC6-AE59-93E493F41D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436E1C-AE34-483F-8718-02141D41E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714BC9-1E0A-4651-8D2F-2AB138DD4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0350BF-1E72-4C2C-AFF6-DE8461531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576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064440-8196-4B3C-8621-AE499FE5A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0D8205F-405B-4A73-957B-CBD5F9A4F2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BF07C1-9E69-456F-958D-59156DF1A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988DCF-DAA3-4CC1-A8C6-640D00BB2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77EFEF-FC4B-4966-B6FB-18A24548E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2473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76FA04-D2C4-456B-8695-2C5ABA3FE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32468D8-4BE0-4C9D-8E16-7AC67627D8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1B4CC1D-E5E8-4918-8C5A-F87DF30875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A89197-03B4-41C6-AAA2-359366F6A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E5562AB-C601-4127-A809-A9232C0DD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7638B83-06D6-41DD-B746-186BA6C1D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8703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5C3B81-EC1A-4435-9D84-9B228D13EA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41D5E3-A2A0-46FD-8785-A2CB44380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FFCB6D3-2167-4B28-81B3-7B2F424985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B5BE3E1-47DC-4E6C-B03D-7A634A4E9F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A8AF25B-6BAD-4B59-B8BC-175E7319C7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0726AC5-7C57-4823-8956-B9E5FF64C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F832DF-8410-468F-A891-C09E230C5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DD86A80-084A-4EBE-A1B8-469FC19DA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8243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F05389-98D9-4143-86C0-37D9A07988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CECC4B4-FAB1-4DA7-810B-1BDE8FD3E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B316B0A-F227-4827-B817-26C86906B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19F25AF-2A44-4F95-9E32-33E67B667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6191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E6813D1-2B61-4576-8D7C-D1D370000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4F71F33-42D6-4C05-BF1A-2CD5DF392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BDB7220-7B75-4EF3-877C-6B8F9CD0C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93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0FE716-1666-4D45-B821-2F6A9A485E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446A7F5-5AF3-4C5B-895E-71FF52C4E7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3FC48A-688A-4B06-9A8B-6A0021762D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628AEA-9B4A-4132-8959-8886529C7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289939A-6633-40CC-A224-D0CABC1ED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F3BAA4-7DED-458C-8B67-27C40699C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1718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EC14D0-7657-4D39-9E58-B73248E5D8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5530B92-FC89-4EFA-8061-4BE3C1BFDD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7D5781B-E850-4458-9F94-DDF1CBF45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F0DB4C8-3FF5-4A60-9AAD-3FE31785F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9D096D-FB9D-434B-B369-3537A22F3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D1F7304-A622-4413-8B24-6C0124EB2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7523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55A4A0C-468E-48D4-8DF5-A69B8704E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F7676C-BA8B-4CEE-AF38-1A09EDEADD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758669-90A8-4177-ACD4-3C51F0834A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2782A-2ACF-4B9F-928F-B2E1876E9D84}" type="datetimeFigureOut">
              <a:rPr lang="zh-CN" altLang="en-US" smtClean="0"/>
              <a:t>2023/3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ED7184-1F9C-4497-9F4A-B856CAC455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902352-4B0B-4EA6-B831-D97FEC46FF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82C27-AD73-48F8-BB39-617048D8F5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0592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34391" y="3131893"/>
            <a:ext cx="115834" cy="37188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9319540" y="3922540"/>
            <a:ext cx="115834" cy="371888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8057" y="289488"/>
            <a:ext cx="8455885" cy="535275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943438" y="5804310"/>
            <a:ext cx="83051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Sequence alignment of human PARG with fly PARG (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ARG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id dots represent the potential O-GlcNAc sites identified by MS in PARG from human or fly cells. The nuclear localization sequences (NLS) of human PARG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AR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marked by single underlines. The catalytic domain of PARG is bracketed. the identical amino acid residues between human PARG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AR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shown by red letters.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0006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08</TotalTime>
  <Words>75</Words>
  <Application>Microsoft Macintosh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珊珊</dc:creator>
  <cp:lastModifiedBy>office user</cp:lastModifiedBy>
  <cp:revision>62</cp:revision>
  <dcterms:created xsi:type="dcterms:W3CDTF">2022-04-22T07:54:14Z</dcterms:created>
  <dcterms:modified xsi:type="dcterms:W3CDTF">2023-03-31T04:08:41Z</dcterms:modified>
</cp:coreProperties>
</file>